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A3A7BC-F5AF-4D8E-BA7E-301CCC2DAD3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036DBE-F13D-4A20-960C-9E58C0F4C3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EDCF74-97FE-4191-AD1C-CC82D53442E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976406-1B0D-4E69-83E8-6011B2910B9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224F34-ED3B-4906-BB04-FC467A00B0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FB00CF-6AC1-46F6-8BE4-FC7D67E6A4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C36A0C-49FA-47E3-A392-D21F5B2744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B73140-A607-449F-9C62-4B23AA6C19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5B443F-3A35-4496-8390-529AE80C6D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12C647-D6AC-4BD2-AB09-5E8E16D9FD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5C239A-D81C-48FE-A43E-4858ACE4F9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21D5C4-9F01-474A-B8BC-DEC32EAB7A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F9E1DAB-E7AA-4E39-8869-26E204578DD7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326880" y="3174840"/>
            <a:ext cx="6235920" cy="563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Figure S1. Evaluation of </a:t>
            </a:r>
            <a:r>
              <a:rPr b="1" i="1" lang="en-US" sz="1400" spc="-1" strike="noStrike">
                <a:solidFill>
                  <a:srgbClr val="000000"/>
                </a:solidFill>
                <a:latin typeface="Times New Roman"/>
              </a:rPr>
              <a:t>ACS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 genes silencing in tomato roots</a:t>
            </a:r>
            <a:r>
              <a:rPr b="1" i="1" lang="en-US" sz="1400" spc="-1" strike="noStrike">
                <a:solidFill>
                  <a:srgbClr val="000000"/>
                </a:solidFill>
                <a:latin typeface="Times New Roman"/>
              </a:rPr>
              <a:t>.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Expression of 1-aminocyclopropane-1-carboxylic acid (ACC) synthase genes (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ACS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) was determined by quantitative RT-PCR (qRT-PCR) using gene-specific primers (Table S2) in two cv. Motelle roots [samples (1) and (2)] co-agroinfiltrated with TRV-ACSI+II or empty vector TRV. Values represent the means ± SE of three technical replicates normalized relative to tomato ubiquitin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Ubi3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gene.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Three weeks after co-agroinfiltration of two silencing constructs TRV-ACSI+II, or empty vector TRV- control, tomato plants were inoculated with 10,000 second-stage juveniles of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Meloidogyne incognita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. Three days after nematode inoculation, a portion of the roots was collected from individual plants for gene expression analysis. Silencing efficiency of A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CS1A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,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ACS1B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,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ACS2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,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ACS4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,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ACS5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and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ACS6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was evaluated in these root samples by qRT-PCR. Transcripts of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ACS1A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,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ACS4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and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ACS5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could not be detected in the control tomato roots. Therefore, results for only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 ACS1B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,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ACS2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and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ACS6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are presented.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For qRT-PCR, transcripts were amplified from 1 µl of 5x diluted cDNA in a 15 µl reaction using gene-specific primers (Table S2) and iQ</a:t>
            </a:r>
            <a:r>
              <a:rPr b="0" lang="en-US" sz="1400" spc="-1" strike="noStrike" baseline="30000">
                <a:solidFill>
                  <a:srgbClr val="000000"/>
                </a:solidFill>
                <a:latin typeface="Times New Roman"/>
              </a:rPr>
              <a:t>TM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SYBR Green Supermix (Bio-Rad) following the protocol: 94°C for 5 min, cycled 45x [94°C for 30 sec, 58°C for 30 sec, and 72°C for 30 sec], and 72°C for 3 min, followed by generation of a dissociation curve. The generated threshold cycle (Ct) was used to calculate the transcript abundance relative to the housekeeping genes (tomato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Ubi3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) as described by 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Ginzinger (2002).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 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 u="sng">
                <a:solidFill>
                  <a:srgbClr val="000000"/>
                </a:solidFill>
                <a:uFillTx/>
                <a:latin typeface="Times New Roman"/>
              </a:rPr>
              <a:t>Reference: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Ginzinger, D.G. (2002). Gene quantification using real-time quantitative PCR: an emerging technology hits the mainstream. </a:t>
            </a:r>
            <a:r>
              <a:rPr b="0" i="1" lang="en-GB" sz="1400" spc="-1" strike="noStrike">
                <a:solidFill>
                  <a:srgbClr val="000000"/>
                </a:solidFill>
                <a:latin typeface="Times New Roman"/>
              </a:rPr>
              <a:t>Exp. Hematol.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 (30): 503-512.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2" name="Group 3"/>
          <p:cNvGrpSpPr/>
          <p:nvPr/>
        </p:nvGrpSpPr>
        <p:grpSpPr>
          <a:xfrm>
            <a:off x="1482840" y="395280"/>
            <a:ext cx="4762440" cy="2809800"/>
            <a:chOff x="1482840" y="395280"/>
            <a:chExt cx="4762440" cy="2809800"/>
          </a:xfrm>
        </p:grpSpPr>
        <p:grpSp>
          <p:nvGrpSpPr>
            <p:cNvPr id="43" name="Group 53"/>
            <p:cNvGrpSpPr/>
            <p:nvPr/>
          </p:nvGrpSpPr>
          <p:grpSpPr>
            <a:xfrm>
              <a:off x="1482840" y="395280"/>
              <a:ext cx="4762440" cy="2809800"/>
              <a:chOff x="1482840" y="395280"/>
              <a:chExt cx="4762440" cy="2809800"/>
            </a:xfrm>
          </p:grpSpPr>
          <p:pic>
            <p:nvPicPr>
              <p:cNvPr id="44" name="Chart 41" descr=""/>
              <p:cNvPicPr/>
              <p:nvPr/>
            </p:nvPicPr>
            <p:blipFill>
              <a:blip r:embed="rId1"/>
              <a:stretch/>
            </p:blipFill>
            <p:spPr>
              <a:xfrm>
                <a:off x="1482840" y="395280"/>
                <a:ext cx="4762440" cy="2809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5" name="Text Box 14"/>
              <p:cNvSpPr/>
              <p:nvPr/>
            </p:nvSpPr>
            <p:spPr>
              <a:xfrm>
                <a:off x="2375280" y="2769840"/>
                <a:ext cx="532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</a:rPr>
                  <a:t>ACS1B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6" name="Text Box 15"/>
              <p:cNvSpPr/>
              <p:nvPr/>
            </p:nvSpPr>
            <p:spPr>
              <a:xfrm>
                <a:off x="3190680" y="2769840"/>
                <a:ext cx="469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</a:rPr>
                  <a:t>ACS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7" name="Text Box 16"/>
              <p:cNvSpPr/>
              <p:nvPr/>
            </p:nvSpPr>
            <p:spPr>
              <a:xfrm>
                <a:off x="3972600" y="2769840"/>
                <a:ext cx="469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</a:rPr>
                  <a:t>ACS6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8" name="Text Box 110"/>
              <p:cNvSpPr/>
              <p:nvPr/>
            </p:nvSpPr>
            <p:spPr>
              <a:xfrm>
                <a:off x="1889280" y="2664720"/>
                <a:ext cx="362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9" name="Text Box 110"/>
              <p:cNvSpPr/>
              <p:nvPr/>
            </p:nvSpPr>
            <p:spPr>
              <a:xfrm>
                <a:off x="1889280" y="2384280"/>
                <a:ext cx="362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0.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0" name="Text Box 110"/>
              <p:cNvSpPr/>
              <p:nvPr/>
            </p:nvSpPr>
            <p:spPr>
              <a:xfrm>
                <a:off x="1889280" y="2113200"/>
                <a:ext cx="362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0.4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1" name="Text Box 110"/>
              <p:cNvSpPr/>
              <p:nvPr/>
            </p:nvSpPr>
            <p:spPr>
              <a:xfrm>
                <a:off x="1889280" y="1833120"/>
                <a:ext cx="362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0.6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" name="Text Box 110"/>
              <p:cNvSpPr/>
              <p:nvPr/>
            </p:nvSpPr>
            <p:spPr>
              <a:xfrm>
                <a:off x="1889280" y="1566720"/>
                <a:ext cx="362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0.8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3" name="Text Box 110"/>
              <p:cNvSpPr/>
              <p:nvPr/>
            </p:nvSpPr>
            <p:spPr>
              <a:xfrm>
                <a:off x="1889280" y="1015560"/>
                <a:ext cx="362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1.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" name="Text Box 110"/>
              <p:cNvSpPr/>
              <p:nvPr/>
            </p:nvSpPr>
            <p:spPr>
              <a:xfrm>
                <a:off x="1889280" y="1291320"/>
                <a:ext cx="362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5" name="Text Box 110"/>
              <p:cNvSpPr/>
              <p:nvPr/>
            </p:nvSpPr>
            <p:spPr>
              <a:xfrm>
                <a:off x="1889280" y="740160"/>
                <a:ext cx="362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1.4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6" name="Text Box 110"/>
              <p:cNvSpPr/>
              <p:nvPr/>
            </p:nvSpPr>
            <p:spPr>
              <a:xfrm>
                <a:off x="1889280" y="459720"/>
                <a:ext cx="362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1.6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7" name="Text Box 106"/>
              <p:cNvSpPr/>
              <p:nvPr/>
            </p:nvSpPr>
            <p:spPr>
              <a:xfrm rot="10800000">
                <a:off x="1688040" y="1069920"/>
                <a:ext cx="302040" cy="1192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Relative amount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58" name="TextBox 2"/>
            <p:cNvSpPr/>
            <p:nvPr/>
          </p:nvSpPr>
          <p:spPr>
            <a:xfrm>
              <a:off x="3081960" y="482400"/>
              <a:ext cx="384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V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16T19:06:35Z</dcterms:created>
  <dc:creator>Isgouhi Kaloshian</dc:creator>
  <dc:description/>
  <dc:language>en-US</dc:language>
  <cp:lastModifiedBy>Isgouhi Kaloshian</cp:lastModifiedBy>
  <cp:lastPrinted>2010-03-17T23:08:22Z</cp:lastPrinted>
  <dcterms:modified xsi:type="dcterms:W3CDTF">2013-03-25T22:51:02Z</dcterms:modified>
  <cp:revision>28</cp:revision>
  <dc:subject/>
  <dc:title>PowerPoint Presentation</dc:title>
</cp:coreProperties>
</file>